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D31682-89A7-475B-AB51-A1E3D65B41C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90AB6C-969A-4958-B04C-71AFB4D88C9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AFA04C-2E51-4AF6-B0CE-813BCE75AD6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60EE1F-FE76-4A3F-9D26-5A0DC666235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405BB5-D925-4B35-A91B-6B08A1FEA5B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0107AA-5CB2-4E51-8A75-C872A8C5973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2D3665-90CF-46F7-A2F5-6842FC83F39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2DE8CF-6BD0-4996-980A-9D1EA429A90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5F7353-2449-4005-B250-669CBB633DE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5CB4CF-C67E-4B1C-A4CE-C78266828F2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B9A528-80A3-4805-8203-2042C60E62B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0C027F-A992-4DFC-9B82-5CA97F45C9E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等线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等线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等线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等线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C502B16-D2F9-41FB-B6B7-67C188EDF863}" type="slidenum">
              <a:rPr b="0" lang="zh-CN" sz="1200" spc="-1" strike="noStrike">
                <a:solidFill>
                  <a:srgbClr val="898989"/>
                </a:solidFill>
                <a:latin typeface="等线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图片 4" descr=""/>
          <p:cNvPicPr/>
          <p:nvPr/>
        </p:nvPicPr>
        <p:blipFill>
          <a:blip r:embed="rId1"/>
          <a:srcRect l="0" t="6580" r="0" b="0"/>
          <a:stretch/>
        </p:blipFill>
        <p:spPr>
          <a:xfrm>
            <a:off x="1523880" y="698400"/>
            <a:ext cx="8666280" cy="6088320"/>
          </a:xfrm>
          <a:prstGeom prst="rect">
            <a:avLst/>
          </a:prstGeom>
          <a:ln w="0">
            <a:noFill/>
          </a:ln>
        </p:spPr>
      </p:pic>
      <p:sp>
        <p:nvSpPr>
          <p:cNvPr id="42" name="文本框 5"/>
          <p:cNvSpPr/>
          <p:nvPr/>
        </p:nvSpPr>
        <p:spPr>
          <a:xfrm>
            <a:off x="1174680" y="152280"/>
            <a:ext cx="9364680" cy="509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14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ure S1. Bacterial rarefaction curves based on number of observed operational taxonomic units (OTUs) for each group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 = 6 per group. L, low birth weight; N, normal birth weight; I, ileum; CO, colon.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3" name="图片 4" descr=""/>
          <p:cNvPicPr/>
          <p:nvPr/>
        </p:nvPicPr>
        <p:blipFill>
          <a:blip r:embed="rId1"/>
          <a:srcRect l="0" t="0" r="3483" b="9454"/>
          <a:stretch/>
        </p:blipFill>
        <p:spPr>
          <a:xfrm>
            <a:off x="0" y="1447920"/>
            <a:ext cx="11949120" cy="3114720"/>
          </a:xfrm>
          <a:prstGeom prst="rect">
            <a:avLst/>
          </a:prstGeom>
          <a:ln w="0">
            <a:noFill/>
          </a:ln>
        </p:spPr>
      </p:pic>
      <p:sp>
        <p:nvSpPr>
          <p:cNvPr id="44" name="文本框 5"/>
          <p:cNvSpPr/>
          <p:nvPr/>
        </p:nvSpPr>
        <p:spPr>
          <a:xfrm>
            <a:off x="808200" y="423720"/>
            <a:ext cx="10575720" cy="509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14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ure S2. Principal coordinate analysis (PCoA) of all samples (A), ileal samples (B), and  colonic samples (C) of LBW and NBW piglets, based on Bray-Curtis distances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n = 6 per group. L, low birth weight; N, normal birth weight; I, ileum; CO, colon. </a:t>
            </a:r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文本框 3"/>
          <p:cNvSpPr/>
          <p:nvPr/>
        </p:nvSpPr>
        <p:spPr>
          <a:xfrm>
            <a:off x="619200" y="98280"/>
            <a:ext cx="10577520" cy="71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14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ure S3. The Heatmap of the gut bacterial community structure in LBW and NBW piglets. The relative abundances of the top 20 taxa at the genus level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Different colors represented the corresponding abundance of each genus (normalized by log 10). n = 6 per group. L, low birth weight; N, normal birth weight; I, ileum; CO, colon. </a:t>
            </a:r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46" name="图片 2" descr=""/>
          <p:cNvPicPr/>
          <p:nvPr/>
        </p:nvPicPr>
        <p:blipFill>
          <a:blip r:embed="rId1"/>
          <a:srcRect l="0" t="4658" r="7464" b="8996"/>
          <a:stretch/>
        </p:blipFill>
        <p:spPr>
          <a:xfrm>
            <a:off x="1922400" y="936720"/>
            <a:ext cx="7577280" cy="59212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文本框 3"/>
          <p:cNvSpPr/>
          <p:nvPr/>
        </p:nvSpPr>
        <p:spPr>
          <a:xfrm>
            <a:off x="619200" y="204840"/>
            <a:ext cx="10682280" cy="509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14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ure S4. Concentrations of organic acids in ileal and colonic samples of piglets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oncentration of organic acids in LBW piglets (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 and  NBW piglets (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). Data are shown as mean ± SEM. **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&lt; 0.01, *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P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 &lt; 0.05. n = 6 per group. LBW, low birth weight; NBW, normal birth weight.</a:t>
            </a:r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  <p:pic>
        <p:nvPicPr>
          <p:cNvPr id="48" name="图片 2" descr=""/>
          <p:cNvPicPr/>
          <p:nvPr/>
        </p:nvPicPr>
        <p:blipFill>
          <a:blip r:embed="rId1"/>
          <a:stretch/>
        </p:blipFill>
        <p:spPr>
          <a:xfrm>
            <a:off x="712800" y="1571760"/>
            <a:ext cx="10510920" cy="39495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9-01-24T12:05:39Z</dcterms:created>
  <dc:creator>Na Li</dc:creator>
  <dc:description/>
  <dc:language>en-US</dc:language>
  <cp:lastModifiedBy>Na Li</cp:lastModifiedBy>
  <dcterms:modified xsi:type="dcterms:W3CDTF">2019-03-20T07:54:08Z</dcterms:modified>
  <cp:revision>6</cp:revision>
  <dc:subject/>
  <dc:title>PowerPoint 演示文稿</dc:title>
</cp:coreProperties>
</file>